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81A6F-C014-4618-BBAC-6E7AFE8E86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4FC61-4387-431F-88E4-5C978275EB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A1885-117F-41C2-BFB9-0A9E5A256A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0A8B5-5C72-48DB-BCB4-C431D3C56A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A853E-5904-40F3-AC28-7332231198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615406-E36F-43E1-A60E-5FB1A301FA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BFCA37-F1E7-4BF5-8EB9-E7661225AE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4EB11-69C6-4E7F-A3AC-3C0FF1AB42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67021-4C74-4B6D-91C0-17CCD7BB0E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FE6233-D18C-4C32-A341-DBD97542D4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1D43ED-F5CD-4AB0-ACB3-DF0D794563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7B6C9-C035-40BA-B30D-E0A49682D4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A8C38A-3455-4E0C-B0CC-A456D5FD824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JEllis@JournalReview.org?subject=Mohs%20math%20-%20where%20the%20error%20hides" TargetMode="External"/><Relationship Id="rId2" Type="http://schemas.openxmlformats.org/officeDocument/2006/relationships/hyperlink" Target="http://www.biomedcentral.com/logon/logon.asp?msg=ce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creativecommons.org/licenses/by/2.0" TargetMode="External"/><Relationship Id="rId5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hyperlink" Target="http://www.biomedcentral.com/1471-5945/6/10" TargetMode="External"/><Relationship Id="rId12" Type="http://schemas.openxmlformats.org/officeDocument/2006/relationships/hyperlink" Target="http://www.biomedcentral.com/1471-5945/6/10" TargetMode="External"/><Relationship Id="rId13" Type="http://schemas.openxmlformats.org/officeDocument/2006/relationships/hyperlink" Target="http://www.biomedcentral.com/1471-5945/6/10" TargetMode="External"/><Relationship Id="rId1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2.png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hyperlink" Target="http://www.biomedcentral.com/1471-5945/6/10" TargetMode="External"/><Relationship Id="rId12" Type="http://schemas.openxmlformats.org/officeDocument/2006/relationships/hyperlink" Target="http://www.biomedcentral.com/1471-5945/6/10" TargetMode="External"/><Relationship Id="rId1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Times New Roman"/>
              </a:rPr>
              <a:t>Mohs math – where the error hides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80773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800"/>
            </a:b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Jeffrey I Ellis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(</a:t>
            </a:r>
            <a:r>
              <a:rPr b="0" lang="en-US" sz="1800" spc="-1" strike="noStrike" u="sng">
                <a:solidFill>
                  <a:srgbClr val="000066"/>
                </a:solidFill>
                <a:uFillTx/>
                <a:latin typeface="Times New Roman"/>
                <a:hlinkClick r:id="rId1"/>
              </a:rPr>
              <a:t>JEllis@JournalReview.org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),  Tatiana Khrom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, Anthony Wong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, Mario O Gentile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and Daniel M Siegel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 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 </a:t>
            </a:r>
            <a:br>
              <a:rPr sz="1800"/>
            </a:b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1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Department of Dermatology, SUNY Downstate Medical Center, Brooklyn, New York, 11203, USA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2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Jxnstudio.com, Philadelphia, Pennsylvania, USA</a:t>
            </a:r>
            <a:br>
              <a:rPr sz="1600"/>
            </a:br>
            <a:br>
              <a:rPr sz="1600"/>
            </a:b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BMC Dermatology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2006,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10     doi:10.1186/1471-5945-6-10</a:t>
            </a:r>
            <a:br>
              <a:rPr sz="1600"/>
            </a:b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The electronic version of this article is the complete one and can be found online at: </a:t>
            </a:r>
            <a:r>
              <a:rPr b="0" lang="en-US" sz="16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http://www.biomedcentral.com/1471-5945/6/10</a:t>
            </a:r>
            <a:br>
              <a:rPr sz="1600"/>
            </a:br>
            <a:br>
              <a:rPr sz="1800"/>
            </a:b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Receiv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 18 August 2006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Accept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 6 December 2006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Publish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 6 December 200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© 2006 Ellis et al; licensee BioMed Central Ltd.</a:t>
            </a:r>
            <a:br>
              <a:rPr sz="900"/>
            </a:b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This is an Open Access article distributed under the terms of the Creative Commons Attribution Licens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(</a:t>
            </a:r>
            <a:r>
              <a:rPr b="0" lang="en-US" sz="9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http://creativecommons.org/licenses/by/2.0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), which permits unrestricted use, distribution, and reproduction in any medium, provided the original work is properly cited.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733320" y="1609560"/>
            <a:ext cx="8029800" cy="4791240"/>
          </a:xfrm>
          <a:prstGeom prst="rect">
            <a:avLst/>
          </a:prstGeom>
          <a:ln w="0">
            <a:noFill/>
          </a:ln>
        </p:spPr>
      </p:pic>
      <p:sp>
        <p:nvSpPr>
          <p:cNvPr id="83" name=""/>
          <p:cNvSpPr/>
          <p:nvPr/>
        </p:nvSpPr>
        <p:spPr>
          <a:xfrm>
            <a:off x="8610480" y="6553080"/>
            <a:ext cx="152640" cy="152640"/>
          </a:xfrm>
          <a:prstGeom prst="ellipse">
            <a:avLst/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" descr=""/>
          <p:cNvPicPr/>
          <p:nvPr/>
        </p:nvPicPr>
        <p:blipFill>
          <a:blip r:embed="rId1"/>
          <a:stretch/>
        </p:blipFill>
        <p:spPr>
          <a:xfrm>
            <a:off x="457200" y="4267080"/>
            <a:ext cx="3257640" cy="1209960"/>
          </a:xfrm>
          <a:prstGeom prst="rect">
            <a:avLst/>
          </a:prstGeom>
          <a:ln w="0">
            <a:noFill/>
          </a:ln>
        </p:spPr>
      </p:pic>
      <p:sp>
        <p:nvSpPr>
          <p:cNvPr id="86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7" name="" descr=""/>
          <p:cNvPicPr/>
          <p:nvPr/>
        </p:nvPicPr>
        <p:blipFill>
          <a:blip r:embed="rId2"/>
          <a:stretch/>
        </p:blipFill>
        <p:spPr>
          <a:xfrm>
            <a:off x="685800" y="1590840"/>
            <a:ext cx="2971800" cy="234288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3"/>
          <a:stretch/>
        </p:blipFill>
        <p:spPr>
          <a:xfrm>
            <a:off x="3762360" y="1438200"/>
            <a:ext cx="5305320" cy="2371680"/>
          </a:xfrm>
          <a:prstGeom prst="rect">
            <a:avLst/>
          </a:prstGeom>
          <a:ln w="0">
            <a:noFill/>
          </a:ln>
        </p:spPr>
      </p:pic>
      <p:pic>
        <p:nvPicPr>
          <p:cNvPr id="89" name="" descr=""/>
          <p:cNvPicPr/>
          <p:nvPr/>
        </p:nvPicPr>
        <p:blipFill>
          <a:blip r:embed="rId4"/>
          <a:stretch/>
        </p:blipFill>
        <p:spPr>
          <a:xfrm>
            <a:off x="3924360" y="3943440"/>
            <a:ext cx="4838760" cy="230508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1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2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3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 –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here resulting in a False Negative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371520" y="3295800"/>
            <a:ext cx="3666960" cy="3333600"/>
          </a:xfrm>
          <a:prstGeom prst="rect">
            <a:avLst/>
          </a:prstGeom>
          <a:ln w="0">
            <a:noFill/>
          </a:ln>
        </p:spPr>
      </p:pic>
      <p:pic>
        <p:nvPicPr>
          <p:cNvPr id="93" name="" descr=""/>
          <p:cNvPicPr/>
          <p:nvPr/>
        </p:nvPicPr>
        <p:blipFill>
          <a:blip r:embed="rId2"/>
          <a:stretch/>
        </p:blipFill>
        <p:spPr>
          <a:xfrm>
            <a:off x="4076640" y="1676520"/>
            <a:ext cx="4686480" cy="348588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3"/>
          <a:stretch/>
        </p:blipFill>
        <p:spPr>
          <a:xfrm>
            <a:off x="914400" y="1523880"/>
            <a:ext cx="2666880" cy="1606680"/>
          </a:xfrm>
          <a:prstGeom prst="rect">
            <a:avLst/>
          </a:prstGeom>
          <a:ln w="0">
            <a:noFill/>
          </a:ln>
        </p:spPr>
      </p:pic>
      <p:sp>
        <p:nvSpPr>
          <p:cNvPr id="95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1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2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685800" y="23619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685800" y="1523880"/>
            <a:ext cx="8381880" cy="495324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2895480" y="4876920"/>
            <a:ext cx="2286000" cy="990360"/>
          </a:xfrm>
          <a:prstGeom prst="ellipse">
            <a:avLst/>
          </a:prstGeom>
          <a:noFill/>
          <a:ln w="57240">
            <a:solidFill>
              <a:srgbClr val="ff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609480" y="763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533520" y="6262560"/>
            <a:ext cx="8229600" cy="3682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From this view, we see that the specimen </a:t>
            </a:r>
            <a:r>
              <a:rPr b="0" i="1" lang="en-US" sz="1800" spc="-1" strike="noStrike">
                <a:solidFill>
                  <a:srgbClr val="ffffff"/>
                </a:solidFill>
                <a:latin typeface="Times New Roman"/>
              </a:rPr>
              <a:t>should</a:t>
            </a: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 demonstrate tumor when processed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695160" y="1676520"/>
            <a:ext cx="8220240" cy="495288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2895480" y="3657600"/>
            <a:ext cx="2286000" cy="990720"/>
          </a:xfrm>
          <a:prstGeom prst="ellipse">
            <a:avLst/>
          </a:prstGeom>
          <a:noFill/>
          <a:ln w="57240">
            <a:solidFill>
              <a:srgbClr val="ff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1676520" y="1752480"/>
            <a:ext cx="5600520" cy="499140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 flipH="1">
            <a:off x="3657600" y="1066680"/>
            <a:ext cx="1752480" cy="205740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5486400" y="533520"/>
            <a:ext cx="31240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Before compressing specimen, one sees tumor at the bas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714240" y="1600200"/>
            <a:ext cx="8048880" cy="477216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2133720" y="2362320"/>
            <a:ext cx="0" cy="83808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2590920" y="1981080"/>
            <a:ext cx="0" cy="114300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3048120" y="1752480"/>
            <a:ext cx="0" cy="121932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3505320" y="1143000"/>
            <a:ext cx="0" cy="160020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3962520" y="838080"/>
            <a:ext cx="0" cy="167652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4495680" y="762120"/>
            <a:ext cx="0" cy="152388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5029200" y="380880"/>
            <a:ext cx="0" cy="182880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5486400" y="228600"/>
            <a:ext cx="0" cy="190512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5638680" y="396720"/>
            <a:ext cx="312444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Asymmetrical compressio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819520" y="4876920"/>
            <a:ext cx="2286000" cy="990360"/>
          </a:xfrm>
          <a:prstGeom prst="ellipse">
            <a:avLst/>
          </a:prstGeom>
          <a:noFill/>
          <a:ln w="57240">
            <a:solidFill>
              <a:srgbClr val="ff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3" name="" descr=""/>
          <p:cNvPicPr/>
          <p:nvPr/>
        </p:nvPicPr>
        <p:blipFill>
          <a:blip r:embed="rId1"/>
          <a:stretch/>
        </p:blipFill>
        <p:spPr>
          <a:xfrm>
            <a:off x="685800" y="1581120"/>
            <a:ext cx="8086680" cy="481968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6" name="" descr=""/>
          <p:cNvPicPr/>
          <p:nvPr/>
        </p:nvPicPr>
        <p:blipFill>
          <a:blip r:embed="rId1"/>
          <a:stretch/>
        </p:blipFill>
        <p:spPr>
          <a:xfrm>
            <a:off x="714240" y="1600200"/>
            <a:ext cx="8124840" cy="481968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Edge Lift Rol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9" name="" descr=""/>
          <p:cNvPicPr/>
          <p:nvPr/>
        </p:nvPicPr>
        <p:blipFill>
          <a:blip r:embed="rId1"/>
          <a:stretch/>
        </p:blipFill>
        <p:spPr>
          <a:xfrm>
            <a:off x="704880" y="1609560"/>
            <a:ext cx="8134200" cy="4867560"/>
          </a:xfrm>
          <a:prstGeom prst="rect">
            <a:avLst/>
          </a:prstGeom>
          <a:ln w="0">
            <a:noFill/>
          </a:ln>
        </p:spPr>
      </p:pic>
      <p:sp>
        <p:nvSpPr>
          <p:cNvPr id="80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09T15:11:40Z</dcterms:created>
  <dc:creator>je</dc:creator>
  <dc:description/>
  <dc:language>en-US</dc:language>
  <cp:lastModifiedBy>JE</cp:lastModifiedBy>
  <dcterms:modified xsi:type="dcterms:W3CDTF">2007-01-03T17:02:42Z</dcterms:modified>
  <cp:revision>4</cp:revision>
  <dc:subject/>
  <dc:title>#1: Edge Lift Roll</dc:title>
</cp:coreProperties>
</file>